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797675" cy="9928225"/>
  <p:defaultTextStyle>
    <a:defPPr>
      <a:defRPr lang="nb-NO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398" y="-3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0" d="100"/>
          <a:sy n="80" d="100"/>
        </p:scale>
        <p:origin x="-3300" y="-78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5EFA44-1748-43A7-8E9A-FE3156781152}" type="datetimeFigureOut">
              <a:rPr lang="nb-NO" smtClean="0"/>
              <a:t>03.10.2015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52DCE6-0491-4F8D-AE0B-17EE713CE62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069054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7AC8DE-BD0D-49BF-95F4-5ED334BCEFEF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D63FEC-4949-4B71-A7AB-C323BF2BA0AF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30404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E5625C-E702-4960-A23A-A326A4D70B0C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7B5F3E-2736-437F-A17C-14B52FED8EF4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24211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B52EFC-65C6-4763-9878-A651C18D35DC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CDC52E-2E64-4E11-BBA8-D8D768317D84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3592903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4A804B-9B7E-47DA-8044-6475BEA3A128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828517-6BEE-492F-B219-8F3AA9C33556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82956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7D9936-F9EE-4A97-AF9E-6E298925E505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B3D47D-5815-401A-B129-51E7CA779146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03666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BFC992-6786-4CFB-A332-E0202ED2188A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3F0759-D031-41CF-AC4D-1A1BEAA3ECD7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67545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2C2999-1C35-47D7-BCFD-37F6CC92481A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E272D2-4371-468E-A6C7-8801BE9B865D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45621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06F6A3-B5F7-49AA-BD6C-678151F80E3E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8A60C8-6171-4AA6-9B87-7D71DCA0FC11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56612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712412-59AF-4A6E-A2BD-002ADD93DD0C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CB8C7E-A831-4C9C-B620-52C5C67235CF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58511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D188CE-64CB-494E-B73D-5794C14163B6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EF4094-C61E-4BE1-B68C-FD5895E79E74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72732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A4939F-0452-4445-9749-94BFB064593C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7EEB80-A2D9-4285-B9E1-7E1888C38A2A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98461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b-NO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FB59C0-F13C-4621-92BC-152A3C509F42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646B06-C587-44B0-8A77-A47FA7C70E54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8643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nb-NO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D6AE0C4-AE46-435D-B718-639357FC5651}" type="datetimeFigureOut">
              <a:rPr lang="nb-NO"/>
              <a:pPr>
                <a:defRPr/>
              </a:pPr>
              <a:t>03.10.2015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0589724D-CA6D-4553-A11D-2955EEC3BFE9}" type="slidenum">
              <a:rPr lang="nb-NO"/>
              <a:pPr>
                <a:defRPr/>
              </a:pPr>
              <a:t>‹#›</a:t>
            </a:fld>
            <a:endParaRPr lang="nb-NO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9512" y="70261"/>
            <a:ext cx="8856984" cy="55092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*        20         *        40         *        60         *        80         *       100         *       120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endParaRPr lang="nb-NO" sz="800" dirty="0" smtClean="0">
              <a:solidFill>
                <a:srgbClr val="000000"/>
              </a:solidFill>
              <a:effectLst/>
              <a:highlight>
                <a:srgbClr val="FFFFFF"/>
              </a:highlight>
              <a:latin typeface="Courier New"/>
              <a:ea typeface="Times New Roman"/>
            </a:endParaRPr>
          </a:p>
          <a:p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d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.........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..D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SRLQ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A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G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YKD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T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FGTNW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L</a:t>
            </a:r>
            <a:b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x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.........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..D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S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G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YRD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T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FGTNW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L</a:t>
            </a:r>
            <a:b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s_Cio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.........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GLE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IQ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E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YRD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S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FGTNW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L</a:t>
            </a:r>
            <a:b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CA1187 : MDNSMEILGLYPTWYQPAL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WVL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SH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T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ELLEY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FL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S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T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ATVASPRGLS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HS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WW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I</a:t>
            </a:r>
            <a:b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VU2484 : ........MDYPVWQLWGING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S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VAQF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HA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A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AEATFW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SMV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S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VIISLISPA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HR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YA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G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*       140         *       160         *       180         *       200         *       220         *       240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endParaRPr lang="nb-NO" sz="800" dirty="0" smtClean="0">
              <a:solidFill>
                <a:srgbClr val="000000"/>
              </a:solidFill>
              <a:effectLst/>
              <a:highlight>
                <a:srgbClr val="FFFFFF"/>
              </a:highlight>
              <a:latin typeface="Courier New"/>
              <a:ea typeface="Times New Roman"/>
            </a:endParaRPr>
          </a:p>
          <a:p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d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KVQ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C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W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ASD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FET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S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AQ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S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LKG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FAF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F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A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x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R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KYQ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W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GAH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IDT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S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FN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SQ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LRG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RNVA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F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S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s_Cio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R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PG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F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S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W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GFEIVDG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PVD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FN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FP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S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AS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LRG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NPA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LS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MWM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CA1187 : 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I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A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K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GRS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I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QER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TE..GG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TFAQILS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CF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AA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DGAFRLEM.TRKLAWVGI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AVL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VU2484 : 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V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YY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K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FED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N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A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FM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GI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..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QT..QGFWD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NP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LLF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ALC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S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S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DERARELM.TGV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WA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I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*       260         *       280         *       300         *       320         *       340         *       360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endParaRPr lang="nb-NO" sz="800" dirty="0" smtClean="0">
              <a:solidFill>
                <a:srgbClr val="000000"/>
              </a:solidFill>
              <a:effectLst/>
              <a:highlight>
                <a:srgbClr val="FFFFFF"/>
              </a:highlight>
              <a:latin typeface="Courier New"/>
              <a:ea typeface="Times New Roman"/>
            </a:endParaRPr>
          </a:p>
          <a:p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d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AAVLS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G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D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LAAI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T.QP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AF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G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QE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N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AL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T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LM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HEERIRNGMKAYSLLEQLRSGSTDQAVRDQFN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x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IIGT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G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Q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LAAM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T.EP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PF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A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QD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N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LL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T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LM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YPRLQRGRMAWLLMQEISQGNREPHVLQAFR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s_Cio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A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APVQA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G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HGLN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IAAM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NSSG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PL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G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MQ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T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LG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K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FP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R..............................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CA1187 : 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FQW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TLP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Q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TR.................................................................................................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VU2484 : M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AWWY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ALPAPQ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RR.................................................................................................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*       380         *       400         *       420         *       440         *       460         *       480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endParaRPr lang="nb-NO" sz="800" dirty="0" smtClean="0">
              <a:solidFill>
                <a:srgbClr val="000000"/>
              </a:solidFill>
              <a:effectLst/>
              <a:highlight>
                <a:srgbClr val="FFFFFF"/>
              </a:highlight>
              <a:latin typeface="Courier New"/>
              <a:ea typeface="Times New Roman"/>
            </a:endParaRPr>
          </a:p>
          <a:p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d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SMKKDLGYGLLLKRYTPNVADATEAQIQQATKDS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VA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Y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C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FWSV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E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P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A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GW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A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YGR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E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x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GLEGDLGYGMLLSRYAPDMNHVTAAQYQAAMRGA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VA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F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C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VML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T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Q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P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A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GW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T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FGR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D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s_Cio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.................................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NST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F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G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M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LR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Q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N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F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G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A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GW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T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R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CA1187 : .......................................LPGSFVPA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AILA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FAA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PG...ALNVPLAG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F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WPEERARESMRKPYVA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VYSNQ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RDVP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VU2484 : .........................................TAD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AFPW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M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FFTRLPSGARVPVAA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CQVGTFEWVRETGRR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VHGVIWSNG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PEAG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                                                                                                   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                  *       500         *       520         *       540         *       560         *       580         *        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endParaRPr lang="nb-NO" sz="800" dirty="0" smtClean="0">
              <a:solidFill>
                <a:srgbClr val="000000"/>
              </a:solidFill>
              <a:effectLst/>
              <a:highlight>
                <a:srgbClr val="FFFFFF"/>
              </a:highlight>
              <a:latin typeface="Courier New"/>
              <a:ea typeface="Times New Roman"/>
            </a:endParaRPr>
          </a:p>
          <a:p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d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G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I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MV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C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LVA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SLKTGRYHFEQSSTTTQPAR.........................................................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c_Cyx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G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LI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FLIA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Y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A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EQPTQQQG.................................................................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err="1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s_Cio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 : 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.AQ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T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TL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F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VYF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LF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Y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T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E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GRET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QKRTPARPLSAAGEGFDEEHDGHAQ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RDQDKRN.............................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MCA1187 : ALGVK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LPALEAR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HP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FI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PQ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RIGEGNELE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HALAIVYCS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C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TTGTRPFGEMFAGNRDAADIERFIK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VTGNMVNMPRIPLRDDEAHALAQFIASLPLWHSITR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DVU2484 : AKSD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E........G</a:t>
            </a:r>
            <a:r>
              <a:rPr lang="nb-NO" sz="800" dirty="0" smtClean="0">
                <a:solidFill>
                  <a:srgbClr val="40004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M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R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SG..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V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KQVAEANMHEA</a:t>
            </a:r>
            <a:r>
              <a:rPr lang="nb-NO" sz="80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RELW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Q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VQC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N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CH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APMIDILPRIANRPLTGVEALITGQG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C0C0C0"/>
                </a:highlight>
                <a:latin typeface="Courier New"/>
                <a:ea typeface="Times New Roman"/>
              </a:rPr>
              <a:t>A</a:t>
            </a:r>
            <a: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  <a:t>L....QGYMPPFVGTPAERRALATYLVNERDARRH..</a:t>
            </a:r>
            <a:br>
              <a:rPr lang="nb-NO" sz="800" dirty="0" smtClean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Courier New"/>
                <a:ea typeface="Times New Roman"/>
              </a:rPr>
            </a:br>
            <a:endParaRPr lang="nb-NO" sz="800" dirty="0"/>
          </a:p>
        </p:txBody>
      </p:sp>
      <p:cxnSp>
        <p:nvCxnSpPr>
          <p:cNvPr id="3" name="Straight Arrow Connector 2"/>
          <p:cNvCxnSpPr/>
          <p:nvPr/>
        </p:nvCxnSpPr>
        <p:spPr>
          <a:xfrm flipV="1">
            <a:off x="2764485" y="103078"/>
            <a:ext cx="0" cy="215900"/>
          </a:xfrm>
          <a:prstGeom prst="straightConnector1">
            <a:avLst/>
          </a:prstGeom>
          <a:ln w="28575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2812662" y="272759"/>
            <a:ext cx="1371631" cy="82162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1</a:t>
            </a:r>
          </a:p>
        </p:txBody>
      </p:sp>
      <p:sp>
        <p:nvSpPr>
          <p:cNvPr id="5" name="Rectangle 4"/>
          <p:cNvSpPr/>
          <p:nvPr/>
        </p:nvSpPr>
        <p:spPr>
          <a:xfrm>
            <a:off x="2451747" y="982334"/>
            <a:ext cx="1604999" cy="87781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1</a:t>
            </a:r>
          </a:p>
        </p:txBody>
      </p:sp>
      <p:sp>
        <p:nvSpPr>
          <p:cNvPr id="6" name="Rectangle 5"/>
          <p:cNvSpPr/>
          <p:nvPr/>
        </p:nvSpPr>
        <p:spPr>
          <a:xfrm>
            <a:off x="4860032" y="265443"/>
            <a:ext cx="1431040" cy="89478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2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032793" y="982333"/>
            <a:ext cx="1368007" cy="86563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2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7433763" y="272758"/>
            <a:ext cx="715520" cy="80943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3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 flipV="1">
            <a:off x="7637369" y="103078"/>
            <a:ext cx="0" cy="215900"/>
          </a:xfrm>
          <a:prstGeom prst="straightConnector1">
            <a:avLst/>
          </a:prstGeom>
          <a:ln w="28575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7270026" y="981114"/>
            <a:ext cx="879258" cy="86563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3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870810" y="1361504"/>
            <a:ext cx="715520" cy="80943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3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860692" y="2069860"/>
            <a:ext cx="686972" cy="86563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3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254602" y="1361504"/>
            <a:ext cx="1431040" cy="89478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4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171330" y="2072298"/>
            <a:ext cx="1427748" cy="92659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4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5508346" y="1362722"/>
            <a:ext cx="1375257" cy="79725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5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5286387" y="2063763"/>
            <a:ext cx="1388476" cy="92659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4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7637369" y="1361504"/>
            <a:ext cx="511915" cy="80943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6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7429741" y="2069859"/>
            <a:ext cx="719543" cy="86563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6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869590" y="2457565"/>
            <a:ext cx="678074" cy="80943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6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852157" y="3173235"/>
            <a:ext cx="551491" cy="86563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6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 flipV="1">
            <a:off x="5658866" y="1183288"/>
            <a:ext cx="0" cy="215900"/>
          </a:xfrm>
          <a:prstGeom prst="straightConnector1">
            <a:avLst/>
          </a:prstGeom>
          <a:ln w="28575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/>
          <p:cNvSpPr/>
          <p:nvPr/>
        </p:nvSpPr>
        <p:spPr>
          <a:xfrm>
            <a:off x="2339752" y="2456367"/>
            <a:ext cx="5809531" cy="82141"/>
          </a:xfrm>
          <a:prstGeom prst="rect">
            <a:avLst/>
          </a:prstGeom>
          <a:gradFill flip="none" rotWithShape="1">
            <a:gsLst>
              <a:gs pos="0">
                <a:srgbClr val="00B0F0">
                  <a:tint val="66000"/>
                  <a:satMod val="160000"/>
                </a:srgbClr>
              </a:gs>
              <a:gs pos="50000">
                <a:srgbClr val="00B0F0">
                  <a:tint val="44500"/>
                  <a:satMod val="160000"/>
                </a:srgbClr>
              </a:gs>
              <a:gs pos="100000">
                <a:srgbClr val="00B0F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err="1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Quinol</a:t>
            </a: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-loop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866460" y="3550476"/>
            <a:ext cx="2598915" cy="79182"/>
          </a:xfrm>
          <a:prstGeom prst="rect">
            <a:avLst/>
          </a:prstGeom>
          <a:gradFill flip="none" rotWithShape="1">
            <a:gsLst>
              <a:gs pos="0">
                <a:srgbClr val="00B0F0">
                  <a:tint val="66000"/>
                  <a:satMod val="160000"/>
                </a:srgbClr>
              </a:gs>
              <a:gs pos="50000">
                <a:srgbClr val="00B0F0">
                  <a:tint val="44500"/>
                  <a:satMod val="160000"/>
                </a:srgbClr>
              </a:gs>
              <a:gs pos="100000">
                <a:srgbClr val="00B0F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err="1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Quinol</a:t>
            </a: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-loop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534654" y="3549933"/>
            <a:ext cx="1375257" cy="79725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7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3467278" y="4272241"/>
            <a:ext cx="1320746" cy="92659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7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5632136" y="3550477"/>
            <a:ext cx="1532152" cy="88872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8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 flipV="1">
            <a:off x="3734045" y="3375910"/>
            <a:ext cx="0" cy="215900"/>
          </a:xfrm>
          <a:prstGeom prst="straightConnector1">
            <a:avLst/>
          </a:prstGeom>
          <a:ln w="28575">
            <a:solidFill>
              <a:schemeClr val="tx1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5163058" y="4271360"/>
            <a:ext cx="1320746" cy="92659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8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1783375" y="4648990"/>
            <a:ext cx="1433872" cy="88872"/>
          </a:xfrm>
          <a:prstGeom prst="rect">
            <a:avLst/>
          </a:prstGeom>
          <a:gradFill flip="none" rotWithShape="1">
            <a:gsLst>
              <a:gs pos="0">
                <a:srgbClr val="00B050">
                  <a:tint val="66000"/>
                  <a:satMod val="160000"/>
                </a:srgbClr>
              </a:gs>
              <a:gs pos="50000">
                <a:srgbClr val="00B050">
                  <a:tint val="44500"/>
                  <a:satMod val="160000"/>
                </a:srgbClr>
              </a:gs>
              <a:gs pos="100000">
                <a:srgbClr val="00B05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nb-NO" sz="800" dirty="0" smtClean="0">
                <a:solidFill>
                  <a:schemeClr val="tx1"/>
                </a:solidFill>
                <a:latin typeface="Courier New" pitchFamily="49" charset="0"/>
                <a:cs typeface="Courier New" pitchFamily="49" charset="0"/>
              </a:rPr>
              <a:t>H9</a:t>
            </a: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3658864" y="5368704"/>
            <a:ext cx="278870" cy="8711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nb-NO" sz="800" dirty="0">
              <a:solidFill>
                <a:schemeClr val="tx1"/>
              </a:solidFill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5056" y="5590047"/>
            <a:ext cx="8882560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Fig. S2. 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Alignment of MCA1187 to cytochrome </a:t>
            </a:r>
            <a:r>
              <a:rPr lang="en-US" sz="1000" i="1" dirty="0" err="1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bd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 subunit I and homologues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The alignment was created using </a:t>
            </a: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ClustalX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 (v2.0) and manually edited using </a:t>
            </a:r>
            <a:b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</a:b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GeneDoc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 2.7. The transmembrane helixes and the quinone binding loop for </a:t>
            </a: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CydA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 from </a:t>
            </a:r>
            <a:r>
              <a:rPr lang="en-US" sz="1000" i="1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E. coli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 are shown above and the predicted transmembrane helixes </a:t>
            </a:r>
            <a:b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</a:b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for MCA1187 are shown below the alignment.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he likely amino acid residues involved in coordinating the haem groups are indicated with down arrows; </a:t>
            </a:r>
          </a:p>
          <a:p>
            <a:r>
              <a:rPr lang="en-US" sz="1000" i="1" dirty="0" smtClean="0">
                <a:latin typeface="Arial" pitchFamily="34" charset="0"/>
                <a:cs typeface="Arial" pitchFamily="34" charset="0"/>
              </a:rPr>
              <a:t>(E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coli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 err="1" smtClean="0">
                <a:latin typeface="Arial" pitchFamily="34" charset="0"/>
                <a:cs typeface="Arial" pitchFamily="34" charset="0"/>
              </a:rPr>
              <a:t>CydA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numbering) haem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000" baseline="-25000" dirty="0" smtClean="0">
                <a:latin typeface="Arial" pitchFamily="34" charset="0"/>
                <a:cs typeface="Arial" pitchFamily="34" charset="0"/>
              </a:rPr>
              <a:t>595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: His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19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haem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: Glu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99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, haem </a:t>
            </a:r>
            <a:r>
              <a:rPr lang="en-US" sz="1000" i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000" baseline="-25000" dirty="0" smtClean="0">
                <a:latin typeface="Arial" pitchFamily="34" charset="0"/>
                <a:cs typeface="Arial" pitchFamily="34" charset="0"/>
              </a:rPr>
              <a:t>558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: His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168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and Met</a:t>
            </a:r>
            <a:r>
              <a:rPr lang="en-US" sz="1000" baseline="30000" dirty="0" smtClean="0">
                <a:latin typeface="Arial" pitchFamily="34" charset="0"/>
                <a:cs typeface="Arial" pitchFamily="34" charset="0"/>
              </a:rPr>
              <a:t>393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The </a:t>
            </a:r>
            <a:r>
              <a:rPr lang="en-US" sz="1000" i="1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c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-type haem binding motif is marked with a black bar below </a:t>
            </a:r>
            <a:b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</a:b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the alignment. </a:t>
            </a: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Ec_CydA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: </a:t>
            </a:r>
            <a:r>
              <a:rPr lang="en-US" sz="1000" i="1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E. coli </a:t>
            </a:r>
            <a:r>
              <a:rPr lang="en-US" sz="1000" dirty="0" err="1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CydA</a:t>
            </a:r>
            <a:r>
              <a:rPr lang="en-US" sz="1000" dirty="0" smtClean="0">
                <a:solidFill>
                  <a:srgbClr val="000000"/>
                </a:solidFill>
                <a:highlight>
                  <a:srgbClr val="FFFFFF"/>
                </a:highlight>
                <a:latin typeface="Arial" pitchFamily="34" charset="0"/>
                <a:cs typeface="Arial" pitchFamily="34" charset="0"/>
              </a:rPr>
              <a:t> (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GI:90111166); </a:t>
            </a:r>
            <a:r>
              <a:rPr lang="nb-NO" sz="1000" dirty="0" err="1" smtClean="0">
                <a:latin typeface="Arial" pitchFamily="34" charset="0"/>
                <a:cs typeface="Arial" pitchFamily="34" charset="0"/>
              </a:rPr>
              <a:t>Ec_CyxA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nb-NO" sz="1000" i="1" dirty="0" smtClean="0">
                <a:latin typeface="Arial" pitchFamily="34" charset="0"/>
                <a:cs typeface="Arial" pitchFamily="34" charset="0"/>
              </a:rPr>
              <a:t>E. coli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nb-NO" sz="1000" dirty="0" err="1" smtClean="0">
                <a:latin typeface="Arial" pitchFamily="34" charset="0"/>
                <a:cs typeface="Arial" pitchFamily="34" charset="0"/>
              </a:rPr>
              <a:t>CyxA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(GI:16128944), </a:t>
            </a:r>
            <a:r>
              <a:rPr lang="nb-NO" sz="1000" dirty="0" err="1" smtClean="0">
                <a:latin typeface="Arial" pitchFamily="34" charset="0"/>
                <a:cs typeface="Arial" pitchFamily="34" charset="0"/>
              </a:rPr>
              <a:t>Ps_CioA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nb-NO" sz="1000" i="1" dirty="0" err="1" smtClean="0">
                <a:latin typeface="Arial" pitchFamily="34" charset="0"/>
                <a:cs typeface="Arial" pitchFamily="34" charset="0"/>
              </a:rPr>
              <a:t>Pseudomonas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nb-NO" sz="1000" i="1" dirty="0" smtClean="0">
                <a:latin typeface="Arial" pitchFamily="34" charset="0"/>
                <a:cs typeface="Arial" pitchFamily="34" charset="0"/>
              </a:rPr>
              <a:t>aeruginosa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nb-NO" sz="1000" dirty="0" err="1" smtClean="0">
                <a:latin typeface="Arial" pitchFamily="34" charset="0"/>
                <a:cs typeface="Arial" pitchFamily="34" charset="0"/>
              </a:rPr>
              <a:t>CioA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n-US" sz="1000" dirty="0" smtClean="0">
                <a:latin typeface="Arial" pitchFamily="34" charset="0"/>
                <a:cs typeface="Arial" pitchFamily="34" charset="0"/>
                <a:sym typeface="Wingdings" pitchFamily="2" charset="2"/>
              </a:rPr>
              <a:t>GI:33483857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), </a:t>
            </a:r>
            <a:br>
              <a:rPr lang="nb-NO" sz="1000" dirty="0" smtClean="0">
                <a:latin typeface="Arial" pitchFamily="34" charset="0"/>
                <a:cs typeface="Arial" pitchFamily="34" charset="0"/>
              </a:rPr>
            </a:br>
            <a:r>
              <a:rPr lang="nb-NO" sz="1000" dirty="0" smtClean="0">
                <a:latin typeface="Arial" pitchFamily="34" charset="0"/>
                <a:cs typeface="Arial" pitchFamily="34" charset="0"/>
              </a:rPr>
              <a:t>MCA1187: </a:t>
            </a:r>
            <a:r>
              <a:rPr lang="nb-NO" sz="1000" i="1" dirty="0" smtClean="0">
                <a:latin typeface="Arial" pitchFamily="34" charset="0"/>
                <a:cs typeface="Arial" pitchFamily="34" charset="0"/>
              </a:rPr>
              <a:t>M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nb-NO" sz="1000" i="1" dirty="0" smtClean="0">
                <a:latin typeface="Arial" pitchFamily="34" charset="0"/>
                <a:cs typeface="Arial" pitchFamily="34" charset="0"/>
              </a:rPr>
              <a:t>capsulatus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gene MCA1187 (GI:53758452), DVU2484: </a:t>
            </a:r>
            <a:r>
              <a:rPr lang="nb-NO" sz="1000" i="1" dirty="0" err="1" smtClean="0">
                <a:latin typeface="Arial" pitchFamily="34" charset="0"/>
                <a:cs typeface="Arial" pitchFamily="34" charset="0"/>
              </a:rPr>
              <a:t>Desulfovibrio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nb-NO" sz="1000" i="1" dirty="0" err="1" smtClean="0">
                <a:latin typeface="Arial" pitchFamily="34" charset="0"/>
                <a:cs typeface="Arial" pitchFamily="34" charset="0"/>
              </a:rPr>
              <a:t>vulgaris</a:t>
            </a:r>
            <a:r>
              <a:rPr lang="nb-NO" sz="1000" dirty="0" smtClean="0">
                <a:latin typeface="Arial" pitchFamily="34" charset="0"/>
                <a:cs typeface="Arial" pitchFamily="34" charset="0"/>
              </a:rPr>
              <a:t> gene DVU2484 (GI:46450308),</a:t>
            </a:r>
            <a:endParaRPr lang="en-US" sz="1000" dirty="0" smtClean="0">
              <a:solidFill>
                <a:srgbClr val="000000"/>
              </a:solidFill>
              <a:highlight>
                <a:srgbClr val="FFFFFF"/>
              </a:highlight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9994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>
        <a:noAutofit/>
      </a:bodyPr>
      <a:lstStyle>
        <a:defPPr algn="l">
          <a:defRPr sz="1000" dirty="0" smtClean="0">
            <a:solidFill>
              <a:srgbClr val="000000"/>
            </a:solidFill>
            <a:highlight>
              <a:srgbClr val="FFFFFF"/>
            </a:highlight>
            <a:latin typeface="Courier New" pitchFamily="49" charset="0"/>
            <a:cs typeface="Courier New" pitchFamily="49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8</TotalTime>
  <Words>64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i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*        20         *        40         *        60         *        80         *       100 Ec_CydA    : ...........ML..DIVELSRLQFALTAMYHFLFVP.LTLGMAFLLAIMETVYVLSGKQIYKDMTKFWGKLFGIN.FALGVATGLTMEFQFGTNWSYYS Mc_CydA    : ...........MIGEDIVNLSRLQFGLTALYHFLFVP.LTLGLAFLLAIMESVYVMTGKEVYKDMTRFWGKLFGIN.FAMGVTTGITLEFQFGTNWSYYS Ec_CyxA    : ...........MW..DVIDLSRWQFALTALYHFLFVP.LTLGLIFLLAIMETIYVVTGKTIYRDMTRFWGKLFGIN.FALGVATGLTMEFQFGTNWSFYS Bs_CydA    : ..............MSELVLARIQFASTTLFHFLFVP.MSIGLVFMVALMETLYLVKKNELYLKMAKFWGHLFLIN.FAVGVVTGILQEFQFGLNWSDYS Gs_CydA    : ...........MNGYDPVLLSRILTELTLTVHIIYAT.IGVGVPLMIAIAQWVGIRKNDMHYILLARRWTRGFVIT.VAVGVVTGTAIGLQLSLLWPNFM Ps_CioA    : ...........MFGLEAIDLARIQFAFTVSFHIIFPA.ITIGLASYLAVLEGLWLKTNEEVYRDLYHFWSKIFAVN.FGMGVVSGLVMAYQFGTNWSHFS Vf_CioA    : ...........MFHLEALDLARIQFAFTVSFHIIFPA.ITIGLASFLAVLEWRWMKTGNPVYKNLYHFWCKIFAVN.FGMGVVSGLVMSYEFGTNWARFS VspiD_0648 : .......MDFPPYYLDHVAGGRLIIGLIASLHVLINHPLAVGAYPILTWMEWWAHKHQRPDIDRLAYRVTSVVFIVTTTVGALTGVGIWVSTSLFAPFAI Tint_2076  : ....MDWVGLYPTWYEPGVGSGWVVGIMATIHVLASH.TSVGAAILFAYLAVLAYRRNQPQLLDYIRKYGMFLLVFSYVIGSITGPGIWFTTTVASPRGI MCA1187    : MDNSMEILGLYPTWYQPALGSGWVLGIIAVVHVLASH.TSVGAALVSTWLATVAVRRNRPELLEYVRRYGVFLLVFSYVLGSITGPGIWFSATVASPRGL DVU2484    : ........MDYPVWQLWGINGGLLVAIISVLHVFVAQ.FAVGGGFLLVHAATRAERAGSAEATFWVKRFTRFFLLLSMVFGGVSGVGIWVIISLISPAAT Glov_1762  : ........MNYPIWFVPAFGGGLLIALVAIVHVFVSH.FAVGGGLYLVLAERKAIKEKSQAIMDFVKKHTKFFMLLTMVFGGLTGVAIWFVISLIHPAAT                                                                                                                                                                                                                                                           *       120         *       140         *       160         *       180         *       200 Ec_CydA    : HYVGDIFGAPLAIEGLMAFFLESTFVGLFFFGWDRLG....KVQHMCVTWLVALGSNLSALWILVANGWMQNPIASDFNFETMRMEMVSFSELVLNPVAQ Mc_CydA    : HYVGDIFGPILASEGLVSF</dc:title>
  <dc:creator>Øivind Larsen</dc:creator>
  <cp:lastModifiedBy>Øivind Larsen</cp:lastModifiedBy>
  <cp:revision>48</cp:revision>
  <cp:lastPrinted>2013-03-05T08:22:41Z</cp:lastPrinted>
  <dcterms:created xsi:type="dcterms:W3CDTF">2012-03-26T14:22:49Z</dcterms:created>
  <dcterms:modified xsi:type="dcterms:W3CDTF">2015-10-03T09:36:51Z</dcterms:modified>
</cp:coreProperties>
</file>